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9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9903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566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7033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705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2270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7498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283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3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5690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157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799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65DA9-981F-4B11-92DA-36C02ACB2EBE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BD3AF-E92B-4C75-B97E-83204C702D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0618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218940" y="90153"/>
            <a:ext cx="11973059" cy="965915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J-tree &amp; PCA between 271 </a:t>
            </a:r>
            <a:r>
              <a:rPr lang="en-US" sz="3200" i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Ipomoea </a:t>
            </a:r>
            <a:r>
              <a:rPr lang="en-US" sz="3200" i="1" dirty="0" err="1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batatas</a:t>
            </a:r>
            <a:r>
              <a:rPr lang="en-US" sz="3200" i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 </a:t>
            </a:r>
            <a:r>
              <a:rPr lang="en-GB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ccessions </a:t>
            </a:r>
            <a:r>
              <a:rPr lang="en-US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omputed with 7,591  polymorphic  SNPs based on the flesh </a:t>
            </a:r>
            <a:r>
              <a:rPr lang="en-US" sz="3200" dirty="0" err="1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olour</a:t>
            </a:r>
            <a:endParaRPr lang="en-GB" sz="3200" dirty="0">
              <a:solidFill>
                <a:srgbClr val="FF000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Oval 7"/>
          <p:cNvSpPr/>
          <p:nvPr/>
        </p:nvSpPr>
        <p:spPr>
          <a:xfrm rot="18975307">
            <a:off x="6747799" y="2462272"/>
            <a:ext cx="1165056" cy="4160646"/>
          </a:xfrm>
          <a:prstGeom prst="ellipse">
            <a:avLst/>
          </a:prstGeom>
          <a:solidFill>
            <a:schemeClr val="accent4">
              <a:lumMod val="60000"/>
              <a:lumOff val="40000"/>
              <a:alpha val="17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B5F8F8F-797B-8389-2623-AFA9A95E4F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346" y="2351531"/>
            <a:ext cx="4151824" cy="372032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8D2CC1B-7BA8-B026-FC14-403DC5A9ED7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3442" y="1972468"/>
            <a:ext cx="4815212" cy="3850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881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udarnaud</dc:creator>
  <cp:lastModifiedBy>Mahaman Mourtala Issa Zakari</cp:lastModifiedBy>
  <cp:revision>2</cp:revision>
  <dcterms:created xsi:type="dcterms:W3CDTF">2023-01-02T11:45:30Z</dcterms:created>
  <dcterms:modified xsi:type="dcterms:W3CDTF">2024-10-09T18:28:08Z</dcterms:modified>
</cp:coreProperties>
</file>